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7772400" cy="100584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D1A646-86FD-47A6-9247-8F66384C2DE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82480" y="893880"/>
            <a:ext cx="6607440" cy="1676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82480" y="2905200"/>
            <a:ext cx="6607440" cy="287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82480" y="6058080"/>
            <a:ext cx="6607440" cy="287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B82304-4C54-4D3A-B801-F105A067092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82480" y="893880"/>
            <a:ext cx="6607440" cy="1676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82480" y="2905200"/>
            <a:ext cx="3224160" cy="287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968280" y="2905200"/>
            <a:ext cx="3224160" cy="287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82480" y="6058080"/>
            <a:ext cx="3224160" cy="287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968280" y="6058080"/>
            <a:ext cx="3224160" cy="287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156E59-F949-4B28-9BA4-34D32E5B0FA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82480" y="893880"/>
            <a:ext cx="6607440" cy="1676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82480" y="2905200"/>
            <a:ext cx="2127240" cy="287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816640" y="2905200"/>
            <a:ext cx="2127240" cy="287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050440" y="2905200"/>
            <a:ext cx="2127240" cy="287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82480" y="6058080"/>
            <a:ext cx="2127240" cy="287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816640" y="6058080"/>
            <a:ext cx="2127240" cy="287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050440" y="6058080"/>
            <a:ext cx="2127240" cy="287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95611E-D05C-4E21-B053-89EC3735BE4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82480" y="893880"/>
            <a:ext cx="6607440" cy="1676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82480" y="2905200"/>
            <a:ext cx="6607440" cy="603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45CA7D-F6B0-4410-B653-FEBCFAA26C4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82480" y="893880"/>
            <a:ext cx="6607440" cy="1676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82480" y="2905200"/>
            <a:ext cx="6607440" cy="6035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5E85D6-D027-4840-9220-90774D1F5DC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82480" y="893880"/>
            <a:ext cx="6607440" cy="1676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82480" y="2905200"/>
            <a:ext cx="3224160" cy="6035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968280" y="2905200"/>
            <a:ext cx="3224160" cy="6035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E6B120-7234-4000-96E4-F3AA144831D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82480" y="893880"/>
            <a:ext cx="6607440" cy="1676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E00013-26C5-48A1-A6BD-94B54A17A3C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82480" y="893880"/>
            <a:ext cx="6607440" cy="7770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E873F7-2EE1-4DC6-8BAA-6C248FA7404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82480" y="893880"/>
            <a:ext cx="6607440" cy="1676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82480" y="2905200"/>
            <a:ext cx="3224160" cy="287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968280" y="2905200"/>
            <a:ext cx="3224160" cy="6035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82480" y="6058080"/>
            <a:ext cx="3224160" cy="287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4DC298-D87B-42EA-8CFC-A26E1881867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82480" y="893880"/>
            <a:ext cx="6607440" cy="1676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82480" y="2905200"/>
            <a:ext cx="3224160" cy="6035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968280" y="2905200"/>
            <a:ext cx="3224160" cy="287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968280" y="6058080"/>
            <a:ext cx="3224160" cy="287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CAA9BB-2D7B-4245-89C7-5FA7A918255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82480" y="893880"/>
            <a:ext cx="6607440" cy="1676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82480" y="2905200"/>
            <a:ext cx="3224160" cy="287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968280" y="2905200"/>
            <a:ext cx="3224160" cy="287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82480" y="6058080"/>
            <a:ext cx="6607440" cy="287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C4B5E4-F755-4788-989F-ABB4B058729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82480" y="893880"/>
            <a:ext cx="6607440" cy="1676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82480" y="2905200"/>
            <a:ext cx="6607440" cy="6035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82480" y="9164160"/>
            <a:ext cx="1619280" cy="669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655720" y="9164160"/>
            <a:ext cx="2460960" cy="669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5570640" y="9164160"/>
            <a:ext cx="1619280" cy="669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D0A3E72-3D3C-41A4-A51E-13CA5E296F96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89"/>
          <p:cNvGrpSpPr/>
          <p:nvPr/>
        </p:nvGrpSpPr>
        <p:grpSpPr>
          <a:xfrm>
            <a:off x="1806480" y="1412640"/>
            <a:ext cx="3481560" cy="2246400"/>
            <a:chOff x="1806480" y="1412640"/>
            <a:chExt cx="3481560" cy="2246400"/>
          </a:xfrm>
        </p:grpSpPr>
        <p:grpSp>
          <p:nvGrpSpPr>
            <p:cNvPr id="42" name="Group 86"/>
            <p:cNvGrpSpPr/>
            <p:nvPr/>
          </p:nvGrpSpPr>
          <p:grpSpPr>
            <a:xfrm>
              <a:off x="1806480" y="1412640"/>
              <a:ext cx="3299040" cy="2246400"/>
              <a:chOff x="1806480" y="1412640"/>
              <a:chExt cx="3299040" cy="2246400"/>
            </a:xfrm>
          </p:grpSpPr>
          <p:grpSp>
            <p:nvGrpSpPr>
              <p:cNvPr id="43" name="Group 3"/>
              <p:cNvGrpSpPr/>
              <p:nvPr/>
            </p:nvGrpSpPr>
            <p:grpSpPr>
              <a:xfrm>
                <a:off x="2125800" y="1522440"/>
                <a:ext cx="304560" cy="1600200"/>
                <a:chOff x="2125800" y="1522440"/>
                <a:chExt cx="304560" cy="1600200"/>
              </a:xfrm>
            </p:grpSpPr>
            <p:sp>
              <p:nvSpPr>
                <p:cNvPr id="44" name="Line 4"/>
                <p:cNvSpPr/>
                <p:nvPr/>
              </p:nvSpPr>
              <p:spPr>
                <a:xfrm>
                  <a:off x="2384640" y="3044880"/>
                  <a:ext cx="45720" cy="14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" name="Line 5"/>
                <p:cNvSpPr/>
                <p:nvPr/>
              </p:nvSpPr>
              <p:spPr>
                <a:xfrm>
                  <a:off x="2384640" y="2630520"/>
                  <a:ext cx="45720" cy="14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" name="Line 6"/>
                <p:cNvSpPr/>
                <p:nvPr/>
              </p:nvSpPr>
              <p:spPr>
                <a:xfrm>
                  <a:off x="2384640" y="2216160"/>
                  <a:ext cx="45720" cy="14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" name="Line 7"/>
                <p:cNvSpPr/>
                <p:nvPr/>
              </p:nvSpPr>
              <p:spPr>
                <a:xfrm>
                  <a:off x="2384640" y="1803240"/>
                  <a:ext cx="45720" cy="180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" name="Line 8"/>
                <p:cNvSpPr/>
                <p:nvPr/>
              </p:nvSpPr>
              <p:spPr>
                <a:xfrm>
                  <a:off x="2384640" y="2836800"/>
                  <a:ext cx="45720" cy="14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" name="Line 9"/>
                <p:cNvSpPr/>
                <p:nvPr/>
              </p:nvSpPr>
              <p:spPr>
                <a:xfrm>
                  <a:off x="2384640" y="2423880"/>
                  <a:ext cx="45720" cy="180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" name="Line 10"/>
                <p:cNvSpPr/>
                <p:nvPr/>
              </p:nvSpPr>
              <p:spPr>
                <a:xfrm>
                  <a:off x="2384640" y="2009520"/>
                  <a:ext cx="45720" cy="180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" name="Line 11"/>
                <p:cNvSpPr/>
                <p:nvPr/>
              </p:nvSpPr>
              <p:spPr>
                <a:xfrm>
                  <a:off x="2384640" y="1596960"/>
                  <a:ext cx="45720" cy="14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" name="Rectangle 12"/>
                <p:cNvSpPr/>
                <p:nvPr/>
              </p:nvSpPr>
              <p:spPr>
                <a:xfrm>
                  <a:off x="2231640" y="2970000"/>
                  <a:ext cx="7092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" name="Rectangle 13"/>
                <p:cNvSpPr/>
                <p:nvPr/>
              </p:nvSpPr>
              <p:spPr>
                <a:xfrm>
                  <a:off x="2125800" y="2762280"/>
                  <a:ext cx="1760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0.2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" name="Rectangle 14"/>
                <p:cNvSpPr/>
                <p:nvPr/>
              </p:nvSpPr>
              <p:spPr>
                <a:xfrm>
                  <a:off x="2125800" y="2555640"/>
                  <a:ext cx="1760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0.4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" name="Rectangle 15"/>
                <p:cNvSpPr/>
                <p:nvPr/>
              </p:nvSpPr>
              <p:spPr>
                <a:xfrm>
                  <a:off x="2125800" y="2349360"/>
                  <a:ext cx="1760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0.6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" name="Rectangle 16"/>
                <p:cNvSpPr/>
                <p:nvPr/>
              </p:nvSpPr>
              <p:spPr>
                <a:xfrm>
                  <a:off x="2125800" y="2141280"/>
                  <a:ext cx="1760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0.8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" name="Rectangle 17"/>
                <p:cNvSpPr/>
                <p:nvPr/>
              </p:nvSpPr>
              <p:spPr>
                <a:xfrm>
                  <a:off x="2125800" y="1935000"/>
                  <a:ext cx="1760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1.0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" name="Rectangle 18"/>
                <p:cNvSpPr/>
                <p:nvPr/>
              </p:nvSpPr>
              <p:spPr>
                <a:xfrm>
                  <a:off x="2125800" y="1728720"/>
                  <a:ext cx="1760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1.2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" name="Rectangle 19"/>
                <p:cNvSpPr/>
                <p:nvPr/>
              </p:nvSpPr>
              <p:spPr>
                <a:xfrm>
                  <a:off x="2125800" y="1522440"/>
                  <a:ext cx="176040" cy="152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000" spc="-1" strike="noStrike">
                      <a:solidFill>
                        <a:srgbClr val="000000"/>
                      </a:solidFill>
                      <a:latin typeface="Arial"/>
                    </a:rPr>
                    <a:t>1.4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60" name="Rectangle 20"/>
              <p:cNvSpPr/>
              <p:nvPr/>
            </p:nvSpPr>
            <p:spPr>
              <a:xfrm>
                <a:off x="2435400" y="1598760"/>
                <a:ext cx="2651040" cy="1447560"/>
              </a:xfrm>
              <a:prstGeom prst="rect">
                <a:avLst/>
              </a:prstGeom>
              <a:noFill/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Rectangle 21"/>
              <p:cNvSpPr/>
              <p:nvPr/>
            </p:nvSpPr>
            <p:spPr>
              <a:xfrm>
                <a:off x="2527200" y="2003400"/>
                <a:ext cx="119160" cy="1044720"/>
              </a:xfrm>
              <a:prstGeom prst="rect">
                <a:avLst/>
              </a:prstGeom>
              <a:noFill/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" name="Rectangle 22"/>
              <p:cNvSpPr/>
              <p:nvPr/>
            </p:nvSpPr>
            <p:spPr>
              <a:xfrm>
                <a:off x="2647800" y="2028960"/>
                <a:ext cx="120960" cy="1020600"/>
              </a:xfrm>
              <a:prstGeom prst="rect">
                <a:avLst/>
              </a:prstGeom>
              <a:solidFill>
                <a:srgbClr val="7f7f7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" name="Rectangle 23"/>
              <p:cNvSpPr/>
              <p:nvPr/>
            </p:nvSpPr>
            <p:spPr>
              <a:xfrm>
                <a:off x="2646360" y="2027160"/>
                <a:ext cx="119160" cy="1020960"/>
              </a:xfrm>
              <a:prstGeom prst="rect">
                <a:avLst/>
              </a:prstGeom>
              <a:noFill/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Line 24"/>
              <p:cNvSpPr/>
              <p:nvPr/>
            </p:nvSpPr>
            <p:spPr>
              <a:xfrm flipV="1">
                <a:off x="2584440" y="1965240"/>
                <a:ext cx="1440" cy="367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080" bIns="-1008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Line 25"/>
              <p:cNvSpPr/>
              <p:nvPr/>
            </p:nvSpPr>
            <p:spPr>
              <a:xfrm>
                <a:off x="2571840" y="1965240"/>
                <a:ext cx="27000" cy="18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" name="Line 26"/>
              <p:cNvSpPr/>
              <p:nvPr/>
            </p:nvSpPr>
            <p:spPr>
              <a:xfrm flipV="1">
                <a:off x="2703600" y="1875960"/>
                <a:ext cx="1440" cy="14940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" name="Line 27"/>
              <p:cNvSpPr/>
              <p:nvPr/>
            </p:nvSpPr>
            <p:spPr>
              <a:xfrm>
                <a:off x="2690640" y="1876320"/>
                <a:ext cx="2700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Rectangle 28"/>
              <p:cNvSpPr/>
              <p:nvPr/>
            </p:nvSpPr>
            <p:spPr>
              <a:xfrm>
                <a:off x="2946240" y="2014560"/>
                <a:ext cx="119160" cy="1033560"/>
              </a:xfrm>
              <a:prstGeom prst="rect">
                <a:avLst/>
              </a:prstGeom>
              <a:noFill/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Rectangle 29"/>
              <p:cNvSpPr/>
              <p:nvPr/>
            </p:nvSpPr>
            <p:spPr>
              <a:xfrm>
                <a:off x="3068640" y="2341440"/>
                <a:ext cx="119160" cy="708120"/>
              </a:xfrm>
              <a:prstGeom prst="rect">
                <a:avLst/>
              </a:prstGeom>
              <a:solidFill>
                <a:srgbClr val="7f7f7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Rectangle 30"/>
              <p:cNvSpPr/>
              <p:nvPr/>
            </p:nvSpPr>
            <p:spPr>
              <a:xfrm>
                <a:off x="3065400" y="2340000"/>
                <a:ext cx="119160" cy="708120"/>
              </a:xfrm>
              <a:prstGeom prst="rect">
                <a:avLst/>
              </a:prstGeom>
              <a:noFill/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Line 31"/>
              <p:cNvSpPr/>
              <p:nvPr/>
            </p:nvSpPr>
            <p:spPr>
              <a:xfrm flipV="1">
                <a:off x="3003480" y="1906560"/>
                <a:ext cx="1800" cy="1065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Line 32"/>
              <p:cNvSpPr/>
              <p:nvPr/>
            </p:nvSpPr>
            <p:spPr>
              <a:xfrm>
                <a:off x="2990880" y="1906560"/>
                <a:ext cx="2700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Line 33"/>
              <p:cNvSpPr/>
              <p:nvPr/>
            </p:nvSpPr>
            <p:spPr>
              <a:xfrm flipV="1">
                <a:off x="3124080" y="2313000"/>
                <a:ext cx="0" cy="2376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Line 34"/>
              <p:cNvSpPr/>
              <p:nvPr/>
            </p:nvSpPr>
            <p:spPr>
              <a:xfrm>
                <a:off x="3110040" y="2313000"/>
                <a:ext cx="27000" cy="14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Rectangle 35"/>
              <p:cNvSpPr/>
              <p:nvPr/>
            </p:nvSpPr>
            <p:spPr>
              <a:xfrm>
                <a:off x="3365640" y="2014560"/>
                <a:ext cx="118800" cy="1033560"/>
              </a:xfrm>
              <a:prstGeom prst="rect">
                <a:avLst/>
              </a:prstGeom>
              <a:noFill/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Rectangle 36"/>
              <p:cNvSpPr/>
              <p:nvPr/>
            </p:nvSpPr>
            <p:spPr>
              <a:xfrm>
                <a:off x="3487680" y="2114640"/>
                <a:ext cx="120600" cy="934920"/>
              </a:xfrm>
              <a:prstGeom prst="rect">
                <a:avLst/>
              </a:prstGeom>
              <a:solidFill>
                <a:srgbClr val="7f7f7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" name="Rectangle 37"/>
              <p:cNvSpPr/>
              <p:nvPr/>
            </p:nvSpPr>
            <p:spPr>
              <a:xfrm>
                <a:off x="3484440" y="2112840"/>
                <a:ext cx="122400" cy="935280"/>
              </a:xfrm>
              <a:prstGeom prst="rect">
                <a:avLst/>
              </a:prstGeom>
              <a:noFill/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Line 38"/>
              <p:cNvSpPr/>
              <p:nvPr/>
            </p:nvSpPr>
            <p:spPr>
              <a:xfrm flipV="1">
                <a:off x="3424320" y="1910880"/>
                <a:ext cx="0" cy="10188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Line 39"/>
              <p:cNvSpPr/>
              <p:nvPr/>
            </p:nvSpPr>
            <p:spPr>
              <a:xfrm>
                <a:off x="3409920" y="1911240"/>
                <a:ext cx="2700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Line 40"/>
              <p:cNvSpPr/>
              <p:nvPr/>
            </p:nvSpPr>
            <p:spPr>
              <a:xfrm flipV="1">
                <a:off x="3543480" y="2028600"/>
                <a:ext cx="1440" cy="824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5640" bIns="3564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Line 41"/>
              <p:cNvSpPr/>
              <p:nvPr/>
            </p:nvSpPr>
            <p:spPr>
              <a:xfrm>
                <a:off x="3530520" y="2028960"/>
                <a:ext cx="2880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82" name="Group 42"/>
              <p:cNvGrpSpPr/>
              <p:nvPr/>
            </p:nvGrpSpPr>
            <p:grpSpPr>
              <a:xfrm>
                <a:off x="4289400" y="1778040"/>
                <a:ext cx="240840" cy="1271520"/>
                <a:chOff x="4289400" y="1778040"/>
                <a:chExt cx="240840" cy="1271520"/>
              </a:xfrm>
            </p:grpSpPr>
            <p:sp>
              <p:nvSpPr>
                <p:cNvPr id="83" name="Rectangle 43"/>
                <p:cNvSpPr/>
                <p:nvPr/>
              </p:nvSpPr>
              <p:spPr>
                <a:xfrm>
                  <a:off x="4289400" y="2014560"/>
                  <a:ext cx="120240" cy="1033200"/>
                </a:xfrm>
                <a:prstGeom prst="rect">
                  <a:avLst/>
                </a:prstGeom>
                <a:noFill/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" name="Rectangle 44"/>
                <p:cNvSpPr/>
                <p:nvPr/>
              </p:nvSpPr>
              <p:spPr>
                <a:xfrm>
                  <a:off x="4411440" y="2076480"/>
                  <a:ext cx="118800" cy="973080"/>
                </a:xfrm>
                <a:prstGeom prst="rect">
                  <a:avLst/>
                </a:prstGeom>
                <a:solidFill>
                  <a:srgbClr val="7f7f7f"/>
                </a:solidFill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" name="Rectangle 45"/>
                <p:cNvSpPr/>
                <p:nvPr/>
              </p:nvSpPr>
              <p:spPr>
                <a:xfrm>
                  <a:off x="4409640" y="2074680"/>
                  <a:ext cx="118800" cy="973080"/>
                </a:xfrm>
                <a:prstGeom prst="rect">
                  <a:avLst/>
                </a:prstGeom>
                <a:noFill/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" name="Line 46"/>
                <p:cNvSpPr/>
                <p:nvPr/>
              </p:nvSpPr>
              <p:spPr>
                <a:xfrm flipV="1">
                  <a:off x="4346280" y="1778040"/>
                  <a:ext cx="0" cy="23472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" name="Line 47"/>
                <p:cNvSpPr/>
                <p:nvPr/>
              </p:nvSpPr>
              <p:spPr>
                <a:xfrm>
                  <a:off x="4331880" y="1778040"/>
                  <a:ext cx="28440" cy="144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" name="Line 48"/>
                <p:cNvSpPr/>
                <p:nvPr/>
              </p:nvSpPr>
              <p:spPr>
                <a:xfrm flipV="1">
                  <a:off x="4465440" y="2044440"/>
                  <a:ext cx="1080" cy="2880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0" bIns="-1800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" name="Line 49"/>
                <p:cNvSpPr/>
                <p:nvPr/>
              </p:nvSpPr>
              <p:spPr>
                <a:xfrm>
                  <a:off x="4452840" y="2044440"/>
                  <a:ext cx="2808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90" name="Group 50"/>
              <p:cNvGrpSpPr/>
              <p:nvPr/>
            </p:nvGrpSpPr>
            <p:grpSpPr>
              <a:xfrm>
                <a:off x="4708440" y="1989000"/>
                <a:ext cx="241200" cy="1060560"/>
                <a:chOff x="4708440" y="1989000"/>
                <a:chExt cx="241200" cy="1060560"/>
              </a:xfrm>
            </p:grpSpPr>
            <p:sp>
              <p:nvSpPr>
                <p:cNvPr id="91" name="Rectangle 51"/>
                <p:cNvSpPr/>
                <p:nvPr/>
              </p:nvSpPr>
              <p:spPr>
                <a:xfrm>
                  <a:off x="4708440" y="2014560"/>
                  <a:ext cx="120600" cy="1033200"/>
                </a:xfrm>
                <a:prstGeom prst="rect">
                  <a:avLst/>
                </a:prstGeom>
                <a:noFill/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" name="Rectangle 52"/>
                <p:cNvSpPr/>
                <p:nvPr/>
              </p:nvSpPr>
              <p:spPr>
                <a:xfrm>
                  <a:off x="4830480" y="2119320"/>
                  <a:ext cx="119160" cy="930240"/>
                </a:xfrm>
                <a:prstGeom prst="rect">
                  <a:avLst/>
                </a:prstGeom>
                <a:solidFill>
                  <a:srgbClr val="7f7f7f"/>
                </a:solidFill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" name="Rectangle 53"/>
                <p:cNvSpPr/>
                <p:nvPr/>
              </p:nvSpPr>
              <p:spPr>
                <a:xfrm>
                  <a:off x="4829040" y="2117520"/>
                  <a:ext cx="118800" cy="930240"/>
                </a:xfrm>
                <a:prstGeom prst="rect">
                  <a:avLst/>
                </a:prstGeom>
                <a:noFill/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" name="Line 54"/>
                <p:cNvSpPr/>
                <p:nvPr/>
              </p:nvSpPr>
              <p:spPr>
                <a:xfrm flipV="1">
                  <a:off x="4765320" y="1989000"/>
                  <a:ext cx="1800" cy="2376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3040" bIns="-2304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" name="Line 55"/>
                <p:cNvSpPr/>
                <p:nvPr/>
              </p:nvSpPr>
              <p:spPr>
                <a:xfrm>
                  <a:off x="4751280" y="1989000"/>
                  <a:ext cx="28440" cy="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" name="Line 56"/>
                <p:cNvSpPr/>
                <p:nvPr/>
              </p:nvSpPr>
              <p:spPr>
                <a:xfrm flipV="1">
                  <a:off x="4885920" y="1993680"/>
                  <a:ext cx="0" cy="12240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7" name="Line 57"/>
                <p:cNvSpPr/>
                <p:nvPr/>
              </p:nvSpPr>
              <p:spPr>
                <a:xfrm>
                  <a:off x="4871880" y="1993680"/>
                  <a:ext cx="28440" cy="1800"/>
                </a:xfrm>
                <a:prstGeom prst="line">
                  <a:avLst/>
                </a:prstGeom>
                <a:ln w="1260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98" name="Line 58"/>
              <p:cNvSpPr/>
              <p:nvPr/>
            </p:nvSpPr>
            <p:spPr>
              <a:xfrm>
                <a:off x="2440080" y="3049560"/>
                <a:ext cx="2097000" cy="14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Rectangle 59"/>
              <p:cNvSpPr/>
              <p:nvPr/>
            </p:nvSpPr>
            <p:spPr>
              <a:xfrm>
                <a:off x="3652920" y="1668600"/>
                <a:ext cx="36360" cy="36360"/>
              </a:xfrm>
              <a:prstGeom prst="rect">
                <a:avLst/>
              </a:prstGeom>
              <a:noFill/>
              <a:ln w="18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Rectangle 60"/>
              <p:cNvSpPr/>
              <p:nvPr/>
            </p:nvSpPr>
            <p:spPr>
              <a:xfrm>
                <a:off x="3729960" y="1643040"/>
                <a:ext cx="2109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GFP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Rectangle 61"/>
              <p:cNvSpPr/>
              <p:nvPr/>
            </p:nvSpPr>
            <p:spPr>
              <a:xfrm>
                <a:off x="3652920" y="1792440"/>
                <a:ext cx="36360" cy="36360"/>
              </a:xfrm>
              <a:prstGeom prst="rect">
                <a:avLst/>
              </a:prstGeom>
              <a:solidFill>
                <a:srgbClr val="808080"/>
              </a:solidFill>
              <a:ln w="18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2" name="Rectangle 62"/>
              <p:cNvSpPr/>
              <p:nvPr/>
            </p:nvSpPr>
            <p:spPr>
              <a:xfrm>
                <a:off x="3729600" y="1766880"/>
                <a:ext cx="53856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HA-Jhdm1a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3" name="Line 63"/>
              <p:cNvSpPr/>
              <p:nvPr/>
            </p:nvSpPr>
            <p:spPr>
              <a:xfrm>
                <a:off x="3654360" y="3198960"/>
                <a:ext cx="1825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Line 64"/>
              <p:cNvSpPr/>
              <p:nvPr/>
            </p:nvSpPr>
            <p:spPr>
              <a:xfrm>
                <a:off x="3657600" y="3198960"/>
                <a:ext cx="0" cy="152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Line 65"/>
              <p:cNvSpPr/>
              <p:nvPr/>
            </p:nvSpPr>
            <p:spPr>
              <a:xfrm>
                <a:off x="4005360" y="3351240"/>
                <a:ext cx="109692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Line 66"/>
              <p:cNvSpPr/>
              <p:nvPr/>
            </p:nvSpPr>
            <p:spPr>
              <a:xfrm>
                <a:off x="5105520" y="3198960"/>
                <a:ext cx="0" cy="152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Line 67"/>
              <p:cNvSpPr/>
              <p:nvPr/>
            </p:nvSpPr>
            <p:spPr>
              <a:xfrm>
                <a:off x="4721400" y="3313080"/>
                <a:ext cx="255240" cy="0"/>
              </a:xfrm>
              <a:prstGeom prst="line">
                <a:avLst/>
              </a:prstGeom>
              <a:ln w="76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Line 68"/>
              <p:cNvSpPr/>
              <p:nvPr/>
            </p:nvSpPr>
            <p:spPr>
              <a:xfrm>
                <a:off x="4246560" y="3319560"/>
                <a:ext cx="328680" cy="0"/>
              </a:xfrm>
              <a:prstGeom prst="line">
                <a:avLst/>
              </a:prstGeom>
              <a:ln w="76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Line 69"/>
              <p:cNvSpPr/>
              <p:nvPr/>
            </p:nvSpPr>
            <p:spPr>
              <a:xfrm>
                <a:off x="2282760" y="3351240"/>
                <a:ext cx="137160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Line 70"/>
              <p:cNvSpPr/>
              <p:nvPr/>
            </p:nvSpPr>
            <p:spPr>
              <a:xfrm>
                <a:off x="2541600" y="3319560"/>
                <a:ext cx="274680" cy="0"/>
              </a:xfrm>
              <a:prstGeom prst="line">
                <a:avLst/>
              </a:prstGeom>
              <a:ln w="76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Line 71"/>
              <p:cNvSpPr/>
              <p:nvPr/>
            </p:nvSpPr>
            <p:spPr>
              <a:xfrm>
                <a:off x="3451320" y="3319560"/>
                <a:ext cx="164880" cy="0"/>
              </a:xfrm>
              <a:prstGeom prst="line">
                <a:avLst/>
              </a:prstGeom>
              <a:ln w="76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Line 72"/>
              <p:cNvSpPr/>
              <p:nvPr/>
            </p:nvSpPr>
            <p:spPr>
              <a:xfrm>
                <a:off x="2975040" y="3313080"/>
                <a:ext cx="274680" cy="0"/>
              </a:xfrm>
              <a:prstGeom prst="line">
                <a:avLst/>
              </a:prstGeom>
              <a:ln w="763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ctr">
                <a:noAutofit/>
              </a:bodyPr>
              <a:p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Text Box 73"/>
              <p:cNvSpPr/>
              <p:nvPr/>
            </p:nvSpPr>
            <p:spPr>
              <a:xfrm>
                <a:off x="2347200" y="3122640"/>
                <a:ext cx="33480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-450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Text Box 74"/>
              <p:cNvSpPr/>
              <p:nvPr/>
            </p:nvSpPr>
            <p:spPr>
              <a:xfrm>
                <a:off x="2613600" y="3122640"/>
                <a:ext cx="33480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-350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Text Box 75"/>
              <p:cNvSpPr/>
              <p:nvPr/>
            </p:nvSpPr>
            <p:spPr>
              <a:xfrm>
                <a:off x="2817000" y="3122640"/>
                <a:ext cx="33480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-330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Text Box 76"/>
              <p:cNvSpPr/>
              <p:nvPr/>
            </p:nvSpPr>
            <p:spPr>
              <a:xfrm>
                <a:off x="3045600" y="3122640"/>
                <a:ext cx="33480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-230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Text Box 77"/>
              <p:cNvSpPr/>
              <p:nvPr/>
            </p:nvSpPr>
            <p:spPr>
              <a:xfrm>
                <a:off x="3369240" y="3122640"/>
                <a:ext cx="29196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-85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Text Box 78"/>
              <p:cNvSpPr/>
              <p:nvPr/>
            </p:nvSpPr>
            <p:spPr>
              <a:xfrm>
                <a:off x="2587680" y="3427560"/>
                <a:ext cx="9907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PEPCK promoter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Text Box 79"/>
              <p:cNvSpPr/>
              <p:nvPr/>
            </p:nvSpPr>
            <p:spPr>
              <a:xfrm>
                <a:off x="4036320" y="3122640"/>
                <a:ext cx="33480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-240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Text Box 80"/>
              <p:cNvSpPr/>
              <p:nvPr/>
            </p:nvSpPr>
            <p:spPr>
              <a:xfrm>
                <a:off x="4340880" y="3122640"/>
                <a:ext cx="33480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-125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Text Box 81"/>
              <p:cNvSpPr/>
              <p:nvPr/>
            </p:nvSpPr>
            <p:spPr>
              <a:xfrm>
                <a:off x="4569480" y="3122640"/>
                <a:ext cx="33480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-115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" name="Text Box 82"/>
              <p:cNvSpPr/>
              <p:nvPr/>
            </p:nvSpPr>
            <p:spPr>
              <a:xfrm>
                <a:off x="4798080" y="3122640"/>
                <a:ext cx="29196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600" spc="-1" strike="noStrike">
                    <a:solidFill>
                      <a:srgbClr val="000000"/>
                    </a:solidFill>
                    <a:latin typeface="Arial"/>
                  </a:rPr>
                  <a:t>-66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" name="Text Box 83"/>
              <p:cNvSpPr/>
              <p:nvPr/>
            </p:nvSpPr>
            <p:spPr>
              <a:xfrm>
                <a:off x="4111920" y="3443400"/>
                <a:ext cx="9853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G6Pase promoter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" name="Text Box 84"/>
              <p:cNvSpPr/>
              <p:nvPr/>
            </p:nvSpPr>
            <p:spPr>
              <a:xfrm rot="16200000">
                <a:off x="1176840" y="2042280"/>
                <a:ext cx="159660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Relative association of Jhdm1a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Arial"/>
                  </a:rPr>
                  <a:t>with promoters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25" name="Line 88"/>
            <p:cNvSpPr/>
            <p:nvPr/>
          </p:nvSpPr>
          <p:spPr>
            <a:xfrm>
              <a:off x="5105520" y="3200400"/>
              <a:ext cx="1825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30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3-07T16:30:28Z</dcterms:created>
  <dc:creator>Information Services</dc:creator>
  <dc:description/>
  <dc:language>en-US</dc:language>
  <cp:lastModifiedBy>Information Services</cp:lastModifiedBy>
  <cp:lastPrinted>2012-03-05T16:48:47Z</cp:lastPrinted>
  <dcterms:modified xsi:type="dcterms:W3CDTF">2012-05-07T18:21:12Z</dcterms:modified>
  <cp:revision>129</cp:revision>
  <dc:subject/>
  <dc:title>PowerPoint Presentation</dc:title>
</cp:coreProperties>
</file>